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5A10A3-9653-4ED7-B783-C9F5CE6C14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EDA682-7BF9-430A-BECF-D56109044B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BC0918-1D50-451B-B4F2-6FBF85A853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86373-BB53-441E-B2FA-08506991A0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765090-CE5E-4D32-B8BE-3A4C85459B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DD6896-FD40-4848-8183-F5FD3299DD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6A5195-2BFF-4F1C-B162-13E3A2AB58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E2DEF-C209-4B43-A74C-5A67914475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6F4A9-FFCA-48CB-A2AA-69646784EA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84F872-A05D-4CCA-96A8-7118D6E79C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AD131-0B8A-464E-AC90-3CD2E8F36A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E6C961-BC43-415F-AAE2-7299B928D9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5E417D-4033-4728-A0CF-D50643E9DDC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28600" y="1219320"/>
            <a:ext cx="8601480" cy="4663440"/>
            <a:chOff x="228600" y="1219320"/>
            <a:chExt cx="8601480" cy="4663440"/>
          </a:xfrm>
        </p:grpSpPr>
        <p:sp>
          <p:nvSpPr>
            <p:cNvPr id="42" name=""/>
            <p:cNvSpPr/>
            <p:nvPr/>
          </p:nvSpPr>
          <p:spPr>
            <a:xfrm>
              <a:off x="685800" y="4572000"/>
              <a:ext cx="8077320" cy="131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Additional File 1: Quantile-quantile plot (Q-Q plot) for the normality testing on the SOD2 expression values from cohort #1 and cohort #2.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The normal Q-Q plots were constructed to compare standardized residues from the ANOVA on the vertical axis to a standard normal population on the horizontal axis. The linearity of the points on the plots suggests that the data are normally distributed.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6206760" y="1219320"/>
              <a:ext cx="1181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ohort #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136240" y="1219320"/>
              <a:ext cx="1181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ohort #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372320" y="4159080"/>
              <a:ext cx="2765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Normal Theoretical quantile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rot="16200000">
              <a:off x="-765720" y="2658960"/>
              <a:ext cx="232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Standardized Residual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7" name=""/>
            <p:cNvGrpSpPr/>
            <p:nvPr/>
          </p:nvGrpSpPr>
          <p:grpSpPr>
            <a:xfrm>
              <a:off x="4801680" y="1662120"/>
              <a:ext cx="4028400" cy="2592000"/>
              <a:chOff x="4801680" y="1662120"/>
              <a:chExt cx="4028400" cy="2592000"/>
            </a:xfrm>
          </p:grpSpPr>
          <p:sp>
            <p:nvSpPr>
              <p:cNvPr id="48" name=""/>
              <p:cNvSpPr/>
              <p:nvPr/>
            </p:nvSpPr>
            <p:spPr>
              <a:xfrm>
                <a:off x="4801680" y="3977640"/>
                <a:ext cx="31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-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5430240" y="3977640"/>
                <a:ext cx="31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6044760" y="3977640"/>
                <a:ext cx="31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7319520" y="397764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6695640" y="397764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7944840" y="397764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8564040" y="397764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5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4910040" y="1662120"/>
                <a:ext cx="3809880" cy="235188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56" name=""/>
            <p:cNvGrpSpPr/>
            <p:nvPr/>
          </p:nvGrpSpPr>
          <p:grpSpPr>
            <a:xfrm>
              <a:off x="520200" y="1566720"/>
              <a:ext cx="4237920" cy="2687760"/>
              <a:chOff x="520200" y="1566720"/>
              <a:chExt cx="4237920" cy="2687760"/>
            </a:xfrm>
          </p:grpSpPr>
          <p:sp>
            <p:nvSpPr>
              <p:cNvPr id="57" name=""/>
              <p:cNvSpPr/>
              <p:nvPr/>
            </p:nvSpPr>
            <p:spPr>
              <a:xfrm>
                <a:off x="520200" y="3795120"/>
                <a:ext cx="31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-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520200" y="3425400"/>
                <a:ext cx="31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520200" y="3057120"/>
                <a:ext cx="31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570960" y="231084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570960" y="26823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570960" y="193644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570960" y="156672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696600" y="3978000"/>
                <a:ext cx="31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-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1334880" y="3978000"/>
                <a:ext cx="31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1963440" y="3978000"/>
                <a:ext cx="31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3242880" y="397800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613960" y="397800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3861720" y="397800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4492080" y="397800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1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838080" y="1661760"/>
                <a:ext cx="3810240" cy="23522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72" name=""/>
            <p:cNvSpPr/>
            <p:nvPr/>
          </p:nvSpPr>
          <p:spPr>
            <a:xfrm>
              <a:off x="5463360" y="4159080"/>
              <a:ext cx="2765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Normal Theoretical quantile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17T18:42:58Z</dcterms:created>
  <dc:creator>Dentistry Computer User</dc:creator>
  <dc:description/>
  <dc:language>en-US</dc:language>
  <cp:lastModifiedBy>Dentistry Computer User</cp:lastModifiedBy>
  <dcterms:modified xsi:type="dcterms:W3CDTF">2010-07-08T19:19:12Z</dcterms:modified>
  <cp:revision>7</cp:revision>
  <dc:subject/>
  <dc:title>Slide 1</dc:title>
</cp:coreProperties>
</file>